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9" r:id="rId2"/>
    <p:sldId id="270" r:id="rId3"/>
    <p:sldId id="271" r:id="rId4"/>
    <p:sldId id="263" r:id="rId5"/>
    <p:sldId id="264" r:id="rId6"/>
    <p:sldId id="265" r:id="rId7"/>
    <p:sldId id="266" r:id="rId8"/>
    <p:sldId id="262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1998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A36534-DC1F-496E-984E-70CC859C1247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52B289-43E5-411E-9E4E-173A8EAD45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39582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1/7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64904"/>
            <a:ext cx="9165476" cy="43131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69667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1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6158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0000000-0008-0000-03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2564904"/>
            <a:ext cx="9122829" cy="42930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19488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2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404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64904"/>
            <a:ext cx="9094516" cy="42797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05333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3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40925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0000000-0008-0000-2F00-00000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643150"/>
            <a:ext cx="9144000" cy="5264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30075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4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83515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0000000-0008-0000-2F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648691"/>
            <a:ext cx="9144000" cy="5264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30075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5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97839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0000000-0008-0000-31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542473"/>
            <a:ext cx="9144000" cy="5264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30075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6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0521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0000000-0008-0000-3400-00000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1613710"/>
            <a:ext cx="9108504" cy="52442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47823" y="476672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7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04752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0000000-0008-0000-1700-00000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896999"/>
            <a:ext cx="7451251" cy="5961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899316" y="435334"/>
            <a:ext cx="18838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8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4383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4</TotalTime>
  <Words>16</Words>
  <Application>Microsoft Office PowerPoint</Application>
  <PresentationFormat>画面に合わせる (4:3)</PresentationFormat>
  <Paragraphs>8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游ゴシック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koba</dc:creator>
  <cp:lastModifiedBy>小林　規俊</cp:lastModifiedBy>
  <cp:revision>42</cp:revision>
  <dcterms:created xsi:type="dcterms:W3CDTF">2021-03-26T08:38:16Z</dcterms:created>
  <dcterms:modified xsi:type="dcterms:W3CDTF">2021-07-28T10:19:43Z</dcterms:modified>
</cp:coreProperties>
</file>